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9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5C7E9-DA66-451A-AA17-2D7D8F8BFBDD}" type="datetimeFigureOut">
              <a:rPr lang="en-GB" smtClean="0"/>
              <a:t>03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1BD3E-15B5-4268-B2E9-91F48519AA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98939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5C7E9-DA66-451A-AA17-2D7D8F8BFBDD}" type="datetimeFigureOut">
              <a:rPr lang="en-GB" smtClean="0"/>
              <a:t>03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1BD3E-15B5-4268-B2E9-91F48519AA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38568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5C7E9-DA66-451A-AA17-2D7D8F8BFBDD}" type="datetimeFigureOut">
              <a:rPr lang="en-GB" smtClean="0"/>
              <a:t>03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1BD3E-15B5-4268-B2E9-91F48519AA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27047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5C7E9-DA66-451A-AA17-2D7D8F8BFBDD}" type="datetimeFigureOut">
              <a:rPr lang="en-GB" smtClean="0"/>
              <a:t>03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1BD3E-15B5-4268-B2E9-91F48519AA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81671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5C7E9-DA66-451A-AA17-2D7D8F8BFBDD}" type="datetimeFigureOut">
              <a:rPr lang="en-GB" smtClean="0"/>
              <a:t>03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1BD3E-15B5-4268-B2E9-91F48519AA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21681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5C7E9-DA66-451A-AA17-2D7D8F8BFBDD}" type="datetimeFigureOut">
              <a:rPr lang="en-GB" smtClean="0"/>
              <a:t>03/06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1BD3E-15B5-4268-B2E9-91F48519AA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42947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5C7E9-DA66-451A-AA17-2D7D8F8BFBDD}" type="datetimeFigureOut">
              <a:rPr lang="en-GB" smtClean="0"/>
              <a:t>03/06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1BD3E-15B5-4268-B2E9-91F48519AA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9278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5C7E9-DA66-451A-AA17-2D7D8F8BFBDD}" type="datetimeFigureOut">
              <a:rPr lang="en-GB" smtClean="0"/>
              <a:t>03/06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1BD3E-15B5-4268-B2E9-91F48519AA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73765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5C7E9-DA66-451A-AA17-2D7D8F8BFBDD}" type="datetimeFigureOut">
              <a:rPr lang="en-GB" smtClean="0"/>
              <a:t>03/06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1BD3E-15B5-4268-B2E9-91F48519AA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51481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5C7E9-DA66-451A-AA17-2D7D8F8BFBDD}" type="datetimeFigureOut">
              <a:rPr lang="en-GB" smtClean="0"/>
              <a:t>03/06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1BD3E-15B5-4268-B2E9-91F48519AA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87181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5C7E9-DA66-451A-AA17-2D7D8F8BFBDD}" type="datetimeFigureOut">
              <a:rPr lang="en-GB" smtClean="0"/>
              <a:t>03/06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1BD3E-15B5-4268-B2E9-91F48519AA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89283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45C7E9-DA66-451A-AA17-2D7D8F8BFBDD}" type="datetimeFigureOut">
              <a:rPr lang="en-GB" smtClean="0"/>
              <a:t>03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61BD3E-15B5-4268-B2E9-91F48519AA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6459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221062" y="231467"/>
            <a:ext cx="10659906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 smtClean="0"/>
              <a:t>Supplementary material 6: table of classical toxicology and variation explained (Q</a:t>
            </a:r>
            <a:r>
              <a:rPr lang="en-GB" b="1" baseline="30000" dirty="0" smtClean="0"/>
              <a:t>2</a:t>
            </a:r>
            <a:r>
              <a:rPr lang="en-GB" b="1" dirty="0" smtClean="0"/>
              <a:t>) linking different data sets.</a:t>
            </a:r>
          </a:p>
          <a:p>
            <a:endParaRPr lang="en-GB" dirty="0"/>
          </a:p>
        </p:txBody>
      </p:sp>
      <p:grpSp>
        <p:nvGrpSpPr>
          <p:cNvPr id="2" name="Group 1"/>
          <p:cNvGrpSpPr/>
          <p:nvPr/>
        </p:nvGrpSpPr>
        <p:grpSpPr>
          <a:xfrm>
            <a:off x="221062" y="1371803"/>
            <a:ext cx="11381079" cy="5148829"/>
            <a:chOff x="221062" y="1371803"/>
            <a:chExt cx="11381079" cy="5148829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21062" y="1371803"/>
              <a:ext cx="9250326" cy="5148829"/>
            </a:xfrm>
            <a:prstGeom prst="rect">
              <a:avLst/>
            </a:prstGeom>
          </p:spPr>
        </p:pic>
        <p:grpSp>
          <p:nvGrpSpPr>
            <p:cNvPr id="6" name="Group 14"/>
            <p:cNvGrpSpPr>
              <a:grpSpLocks/>
            </p:cNvGrpSpPr>
            <p:nvPr/>
          </p:nvGrpSpPr>
          <p:grpSpPr bwMode="auto">
            <a:xfrm>
              <a:off x="9770615" y="1371804"/>
              <a:ext cx="1831526" cy="1397037"/>
              <a:chOff x="4283968" y="4716029"/>
              <a:chExt cx="3272116" cy="1605335"/>
            </a:xfrm>
          </p:grpSpPr>
          <p:pic>
            <p:nvPicPr>
              <p:cNvPr id="7" name="Picture 15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283968" y="4744194"/>
                <a:ext cx="438150" cy="15716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8" name="Rectangle 16"/>
              <p:cNvSpPr>
                <a:spLocks noChangeArrowheads="1"/>
              </p:cNvSpPr>
              <p:nvPr/>
            </p:nvSpPr>
            <p:spPr bwMode="auto">
              <a:xfrm>
                <a:off x="4644008" y="4716029"/>
                <a:ext cx="2912076" cy="3331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lr>
                    <a:srgbClr val="830051"/>
                  </a:buClr>
                  <a:buChar char="•"/>
                  <a:defRPr sz="2000">
                    <a:solidFill>
                      <a:srgbClr val="766A62"/>
                    </a:solidFill>
                    <a:latin typeface="Verdana" panose="020B060403050404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lr>
                    <a:srgbClr val="830051"/>
                  </a:buClr>
                  <a:buChar char="•"/>
                  <a:defRPr sz="2000">
                    <a:solidFill>
                      <a:srgbClr val="766A62"/>
                    </a:solidFill>
                    <a:latin typeface="Verdana" panose="020B060403050404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lr>
                    <a:srgbClr val="830051"/>
                  </a:buClr>
                  <a:buChar char="•"/>
                  <a:defRPr>
                    <a:solidFill>
                      <a:srgbClr val="766A62"/>
                    </a:solidFill>
                    <a:latin typeface="Verdana" panose="020B060403050404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lr>
                    <a:srgbClr val="830051"/>
                  </a:buClr>
                  <a:buChar char="–"/>
                  <a:defRPr>
                    <a:solidFill>
                      <a:srgbClr val="766A62"/>
                    </a:solidFill>
                    <a:latin typeface="Verdana" panose="020B060403050404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lr>
                    <a:srgbClr val="830051"/>
                  </a:buClr>
                  <a:buChar char="»"/>
                  <a:defRPr i="1">
                    <a:solidFill>
                      <a:srgbClr val="766A62"/>
                    </a:solidFill>
                    <a:latin typeface="Verdana" panose="020B060403050404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830051"/>
                  </a:buClr>
                  <a:buChar char="»"/>
                  <a:defRPr i="1">
                    <a:solidFill>
                      <a:srgbClr val="766A62"/>
                    </a:solidFill>
                    <a:latin typeface="Verdana" panose="020B060403050404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830051"/>
                  </a:buClr>
                  <a:buChar char="»"/>
                  <a:defRPr i="1">
                    <a:solidFill>
                      <a:srgbClr val="766A62"/>
                    </a:solidFill>
                    <a:latin typeface="Verdana" panose="020B060403050404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830051"/>
                  </a:buClr>
                  <a:buChar char="»"/>
                  <a:defRPr i="1">
                    <a:solidFill>
                      <a:srgbClr val="766A62"/>
                    </a:solidFill>
                    <a:latin typeface="Verdana" panose="020B060403050404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830051"/>
                  </a:buClr>
                  <a:buChar char="»"/>
                  <a:defRPr i="1">
                    <a:solidFill>
                      <a:srgbClr val="766A62"/>
                    </a:solidFill>
                    <a:latin typeface="Verdana" panose="020B0604030504040204" pitchFamily="34" charset="0"/>
                  </a:defRPr>
                </a:lvl9pPr>
              </a:lstStyle>
              <a:p>
                <a:pPr>
                  <a:lnSpc>
                    <a:spcPct val="107000"/>
                  </a:lnSpc>
                  <a:spcBef>
                    <a:spcPct val="0"/>
                  </a:spcBef>
                  <a:spcAft>
                    <a:spcPts val="800"/>
                  </a:spcAft>
                  <a:buClrTx/>
                  <a:buFontTx/>
                  <a:buNone/>
                </a:pPr>
                <a:r>
                  <a:rPr lang="en-GB" altLang="en-US" sz="1200" dirty="0">
                    <a:solidFill>
                      <a:schemeClr val="tx1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Max var. explained </a:t>
                </a:r>
                <a:r>
                  <a:rPr lang="en-GB" altLang="en-US" sz="1200" dirty="0" smtClean="0">
                    <a:solidFill>
                      <a:schemeClr val="tx1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(Q</a:t>
                </a:r>
                <a:r>
                  <a:rPr lang="en-GB" altLang="en-US" sz="1200" baseline="30000" dirty="0" smtClean="0">
                    <a:solidFill>
                      <a:schemeClr val="tx1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2</a:t>
                </a:r>
                <a:r>
                  <a:rPr lang="en-GB" altLang="en-US" sz="1200" dirty="0">
                    <a:solidFill>
                      <a:schemeClr val="tx1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)</a:t>
                </a:r>
              </a:p>
            </p:txBody>
          </p:sp>
          <p:sp>
            <p:nvSpPr>
              <p:cNvPr id="9" name="Rectangle 17"/>
              <p:cNvSpPr>
                <a:spLocks noChangeArrowheads="1"/>
              </p:cNvSpPr>
              <p:nvPr/>
            </p:nvSpPr>
            <p:spPr bwMode="auto">
              <a:xfrm>
                <a:off x="4658842" y="5988181"/>
                <a:ext cx="2868775" cy="3331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lr>
                    <a:srgbClr val="830051"/>
                  </a:buClr>
                  <a:buChar char="•"/>
                  <a:defRPr sz="2000">
                    <a:solidFill>
                      <a:srgbClr val="766A62"/>
                    </a:solidFill>
                    <a:latin typeface="Verdana" panose="020B060403050404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lr>
                    <a:srgbClr val="830051"/>
                  </a:buClr>
                  <a:buChar char="•"/>
                  <a:defRPr sz="2000">
                    <a:solidFill>
                      <a:srgbClr val="766A62"/>
                    </a:solidFill>
                    <a:latin typeface="Verdana" panose="020B060403050404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lr>
                    <a:srgbClr val="830051"/>
                  </a:buClr>
                  <a:buChar char="•"/>
                  <a:defRPr>
                    <a:solidFill>
                      <a:srgbClr val="766A62"/>
                    </a:solidFill>
                    <a:latin typeface="Verdana" panose="020B060403050404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lr>
                    <a:srgbClr val="830051"/>
                  </a:buClr>
                  <a:buChar char="–"/>
                  <a:defRPr>
                    <a:solidFill>
                      <a:srgbClr val="766A62"/>
                    </a:solidFill>
                    <a:latin typeface="Verdana" panose="020B060403050404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lr>
                    <a:srgbClr val="830051"/>
                  </a:buClr>
                  <a:buChar char="»"/>
                  <a:defRPr i="1">
                    <a:solidFill>
                      <a:srgbClr val="766A62"/>
                    </a:solidFill>
                    <a:latin typeface="Verdana" panose="020B060403050404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830051"/>
                  </a:buClr>
                  <a:buChar char="»"/>
                  <a:defRPr i="1">
                    <a:solidFill>
                      <a:srgbClr val="766A62"/>
                    </a:solidFill>
                    <a:latin typeface="Verdana" panose="020B060403050404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830051"/>
                  </a:buClr>
                  <a:buChar char="»"/>
                  <a:defRPr i="1">
                    <a:solidFill>
                      <a:srgbClr val="766A62"/>
                    </a:solidFill>
                    <a:latin typeface="Verdana" panose="020B060403050404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830051"/>
                  </a:buClr>
                  <a:buChar char="»"/>
                  <a:defRPr i="1">
                    <a:solidFill>
                      <a:srgbClr val="766A62"/>
                    </a:solidFill>
                    <a:latin typeface="Verdana" panose="020B060403050404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lr>
                    <a:srgbClr val="830051"/>
                  </a:buClr>
                  <a:buChar char="»"/>
                  <a:defRPr i="1">
                    <a:solidFill>
                      <a:srgbClr val="766A62"/>
                    </a:solidFill>
                    <a:latin typeface="Verdana" panose="020B0604030504040204" pitchFamily="34" charset="0"/>
                  </a:defRPr>
                </a:lvl9pPr>
              </a:lstStyle>
              <a:p>
                <a:pPr>
                  <a:lnSpc>
                    <a:spcPct val="107000"/>
                  </a:lnSpc>
                  <a:spcBef>
                    <a:spcPct val="0"/>
                  </a:spcBef>
                  <a:spcAft>
                    <a:spcPts val="800"/>
                  </a:spcAft>
                  <a:buClrTx/>
                  <a:buFontTx/>
                  <a:buNone/>
                </a:pPr>
                <a:r>
                  <a:rPr lang="en-GB" altLang="en-US" sz="1200" dirty="0">
                    <a:solidFill>
                      <a:schemeClr val="tx1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Min var. explained </a:t>
                </a:r>
                <a:r>
                  <a:rPr lang="en-GB" altLang="en-US" sz="1200" dirty="0" smtClean="0">
                    <a:solidFill>
                      <a:schemeClr val="tx1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(Q</a:t>
                </a:r>
                <a:r>
                  <a:rPr lang="en-GB" altLang="en-US" sz="1200" baseline="30000" dirty="0" smtClean="0">
                    <a:solidFill>
                      <a:schemeClr val="tx1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2</a:t>
                </a:r>
                <a:r>
                  <a:rPr lang="en-GB" altLang="en-US" sz="1200" dirty="0">
                    <a:solidFill>
                      <a:schemeClr val="tx1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)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1640674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2</TotalTime>
  <Words>33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HN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imesh Acharjee</dc:creator>
  <cp:lastModifiedBy>Animesh Acharjee</cp:lastModifiedBy>
  <cp:revision>6</cp:revision>
  <dcterms:created xsi:type="dcterms:W3CDTF">2015-10-29T10:53:41Z</dcterms:created>
  <dcterms:modified xsi:type="dcterms:W3CDTF">2016-06-03T08:52:13Z</dcterms:modified>
</cp:coreProperties>
</file>